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583363" cy="4297363"/>
  <p:notesSz cx="6858000" cy="9144000"/>
  <p:defaultTextStyle>
    <a:defPPr>
      <a:defRPr lang="en-US"/>
    </a:defPPr>
    <a:lvl1pPr marL="0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73723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747445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121168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494890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868614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242337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616059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989782" algn="l" defTabSz="747445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1710" y="-408"/>
      </p:cViewPr>
      <p:guideLst>
        <p:guide orient="horz" pos="1354"/>
        <p:guide pos="207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Documents\Notre%20Dame\Laboratory%20related\Lab%20Pub%20drafts\CGH-Descriptive\New%20data%20analysis%20(SU)\EventTable-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110237860773347"/>
          <c:y val="0.14316910386201803"/>
          <c:w val="0.84962473749835976"/>
          <c:h val="0.5756351365170298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0(no event), 1(loss), 2(gain)'!$B$197</c:f>
              <c:strCache>
                <c:ptCount val="1"/>
                <c:pt idx="0">
                  <c:v>Losse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0(no event), 1(loss), 2(gain)'!$A$198:$A$233</c:f>
              <c:strCache>
                <c:ptCount val="36"/>
                <c:pt idx="0">
                  <c:v>DD2</c:v>
                </c:pt>
                <c:pt idx="1">
                  <c:v>GC06</c:v>
                </c:pt>
                <c:pt idx="2">
                  <c:v>7C20</c:v>
                </c:pt>
                <c:pt idx="3">
                  <c:v>TC08</c:v>
                </c:pt>
                <c:pt idx="4">
                  <c:v>7C7</c:v>
                </c:pt>
                <c:pt idx="5">
                  <c:v>B4R3</c:v>
                </c:pt>
                <c:pt idx="6">
                  <c:v>QC34</c:v>
                </c:pt>
                <c:pt idx="7">
                  <c:v>3BD5</c:v>
                </c:pt>
                <c:pt idx="8">
                  <c:v>7C424</c:v>
                </c:pt>
                <c:pt idx="9">
                  <c:v>CH3-61</c:v>
                </c:pt>
                <c:pt idx="10">
                  <c:v>7C140</c:v>
                </c:pt>
                <c:pt idx="11">
                  <c:v>3BA6</c:v>
                </c:pt>
                <c:pt idx="12">
                  <c:v>QC13</c:v>
                </c:pt>
                <c:pt idx="13">
                  <c:v>7C16</c:v>
                </c:pt>
                <c:pt idx="14">
                  <c:v>7C408</c:v>
                </c:pt>
                <c:pt idx="15">
                  <c:v>7C12</c:v>
                </c:pt>
                <c:pt idx="16">
                  <c:v>7C3</c:v>
                </c:pt>
                <c:pt idx="17">
                  <c:v>7C159</c:v>
                </c:pt>
                <c:pt idx="18">
                  <c:v>7C188</c:v>
                </c:pt>
                <c:pt idx="19">
                  <c:v>7C111</c:v>
                </c:pt>
                <c:pt idx="20">
                  <c:v>7C183</c:v>
                </c:pt>
                <c:pt idx="21">
                  <c:v>CH3-116</c:v>
                </c:pt>
                <c:pt idx="22">
                  <c:v>SC01</c:v>
                </c:pt>
                <c:pt idx="23">
                  <c:v>GC03</c:v>
                </c:pt>
                <c:pt idx="24">
                  <c:v>B1SD</c:v>
                </c:pt>
                <c:pt idx="25">
                  <c:v>7C170</c:v>
                </c:pt>
                <c:pt idx="26">
                  <c:v>7C101</c:v>
                </c:pt>
                <c:pt idx="27">
                  <c:v>TC05</c:v>
                </c:pt>
                <c:pt idx="28">
                  <c:v>7C126</c:v>
                </c:pt>
                <c:pt idx="29">
                  <c:v>D43</c:v>
                </c:pt>
                <c:pt idx="30">
                  <c:v>QC23</c:v>
                </c:pt>
                <c:pt idx="31">
                  <c:v>7C46</c:v>
                </c:pt>
                <c:pt idx="32">
                  <c:v>SC05</c:v>
                </c:pt>
                <c:pt idx="33">
                  <c:v>1BB5</c:v>
                </c:pt>
                <c:pt idx="34">
                  <c:v>7C421</c:v>
                </c:pt>
                <c:pt idx="35">
                  <c:v>QC01</c:v>
                </c:pt>
              </c:strCache>
            </c:strRef>
          </c:cat>
          <c:val>
            <c:numRef>
              <c:f>'0(no event), 1(loss), 2(gain)'!$B$198:$B$233</c:f>
              <c:numCache>
                <c:formatCode>General</c:formatCode>
                <c:ptCount val="36"/>
                <c:pt idx="0">
                  <c:v>24</c:v>
                </c:pt>
                <c:pt idx="1">
                  <c:v>11</c:v>
                </c:pt>
                <c:pt idx="2">
                  <c:v>6</c:v>
                </c:pt>
                <c:pt idx="3">
                  <c:v>22</c:v>
                </c:pt>
                <c:pt idx="4">
                  <c:v>8</c:v>
                </c:pt>
                <c:pt idx="5">
                  <c:v>22</c:v>
                </c:pt>
                <c:pt idx="6">
                  <c:v>6</c:v>
                </c:pt>
                <c:pt idx="7">
                  <c:v>8</c:v>
                </c:pt>
                <c:pt idx="8">
                  <c:v>14</c:v>
                </c:pt>
                <c:pt idx="9">
                  <c:v>25</c:v>
                </c:pt>
                <c:pt idx="10">
                  <c:v>10</c:v>
                </c:pt>
                <c:pt idx="11">
                  <c:v>5</c:v>
                </c:pt>
                <c:pt idx="12">
                  <c:v>6</c:v>
                </c:pt>
                <c:pt idx="13">
                  <c:v>10</c:v>
                </c:pt>
                <c:pt idx="14">
                  <c:v>12</c:v>
                </c:pt>
                <c:pt idx="15">
                  <c:v>16</c:v>
                </c:pt>
                <c:pt idx="16">
                  <c:v>8</c:v>
                </c:pt>
                <c:pt idx="17">
                  <c:v>9</c:v>
                </c:pt>
                <c:pt idx="18">
                  <c:v>8</c:v>
                </c:pt>
                <c:pt idx="19">
                  <c:v>32</c:v>
                </c:pt>
                <c:pt idx="20">
                  <c:v>8</c:v>
                </c:pt>
                <c:pt idx="21">
                  <c:v>23</c:v>
                </c:pt>
                <c:pt idx="22">
                  <c:v>24</c:v>
                </c:pt>
                <c:pt idx="23">
                  <c:v>5</c:v>
                </c:pt>
                <c:pt idx="24">
                  <c:v>8</c:v>
                </c:pt>
                <c:pt idx="25">
                  <c:v>5</c:v>
                </c:pt>
                <c:pt idx="26">
                  <c:v>8</c:v>
                </c:pt>
                <c:pt idx="27">
                  <c:v>12</c:v>
                </c:pt>
                <c:pt idx="28">
                  <c:v>7</c:v>
                </c:pt>
                <c:pt idx="29">
                  <c:v>7</c:v>
                </c:pt>
                <c:pt idx="30">
                  <c:v>7</c:v>
                </c:pt>
                <c:pt idx="31">
                  <c:v>8</c:v>
                </c:pt>
                <c:pt idx="32">
                  <c:v>3</c:v>
                </c:pt>
                <c:pt idx="33">
                  <c:v>10</c:v>
                </c:pt>
                <c:pt idx="34">
                  <c:v>8</c:v>
                </c:pt>
                <c:pt idx="35">
                  <c:v>4</c:v>
                </c:pt>
              </c:numCache>
            </c:numRef>
          </c:val>
        </c:ser>
        <c:ser>
          <c:idx val="1"/>
          <c:order val="1"/>
          <c:tx>
            <c:strRef>
              <c:f>'0(no event), 1(loss), 2(gain)'!$C$197</c:f>
              <c:strCache>
                <c:ptCount val="1"/>
                <c:pt idx="0">
                  <c:v>Gains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</c:spPr>
          <c:invertIfNegative val="0"/>
          <c:cat>
            <c:strRef>
              <c:f>'0(no event), 1(loss), 2(gain)'!$A$198:$A$233</c:f>
              <c:strCache>
                <c:ptCount val="36"/>
                <c:pt idx="0">
                  <c:v>DD2</c:v>
                </c:pt>
                <c:pt idx="1">
                  <c:v>GC06</c:v>
                </c:pt>
                <c:pt idx="2">
                  <c:v>7C20</c:v>
                </c:pt>
                <c:pt idx="3">
                  <c:v>TC08</c:v>
                </c:pt>
                <c:pt idx="4">
                  <c:v>7C7</c:v>
                </c:pt>
                <c:pt idx="5">
                  <c:v>B4R3</c:v>
                </c:pt>
                <c:pt idx="6">
                  <c:v>QC34</c:v>
                </c:pt>
                <c:pt idx="7">
                  <c:v>3BD5</c:v>
                </c:pt>
                <c:pt idx="8">
                  <c:v>7C424</c:v>
                </c:pt>
                <c:pt idx="9">
                  <c:v>CH3-61</c:v>
                </c:pt>
                <c:pt idx="10">
                  <c:v>7C140</c:v>
                </c:pt>
                <c:pt idx="11">
                  <c:v>3BA6</c:v>
                </c:pt>
                <c:pt idx="12">
                  <c:v>QC13</c:v>
                </c:pt>
                <c:pt idx="13">
                  <c:v>7C16</c:v>
                </c:pt>
                <c:pt idx="14">
                  <c:v>7C408</c:v>
                </c:pt>
                <c:pt idx="15">
                  <c:v>7C12</c:v>
                </c:pt>
                <c:pt idx="16">
                  <c:v>7C3</c:v>
                </c:pt>
                <c:pt idx="17">
                  <c:v>7C159</c:v>
                </c:pt>
                <c:pt idx="18">
                  <c:v>7C188</c:v>
                </c:pt>
                <c:pt idx="19">
                  <c:v>7C111</c:v>
                </c:pt>
                <c:pt idx="20">
                  <c:v>7C183</c:v>
                </c:pt>
                <c:pt idx="21">
                  <c:v>CH3-116</c:v>
                </c:pt>
                <c:pt idx="22">
                  <c:v>SC01</c:v>
                </c:pt>
                <c:pt idx="23">
                  <c:v>GC03</c:v>
                </c:pt>
                <c:pt idx="24">
                  <c:v>B1SD</c:v>
                </c:pt>
                <c:pt idx="25">
                  <c:v>7C170</c:v>
                </c:pt>
                <c:pt idx="26">
                  <c:v>7C101</c:v>
                </c:pt>
                <c:pt idx="27">
                  <c:v>TC05</c:v>
                </c:pt>
                <c:pt idx="28">
                  <c:v>7C126</c:v>
                </c:pt>
                <c:pt idx="29">
                  <c:v>D43</c:v>
                </c:pt>
                <c:pt idx="30">
                  <c:v>QC23</c:v>
                </c:pt>
                <c:pt idx="31">
                  <c:v>7C46</c:v>
                </c:pt>
                <c:pt idx="32">
                  <c:v>SC05</c:v>
                </c:pt>
                <c:pt idx="33">
                  <c:v>1BB5</c:v>
                </c:pt>
                <c:pt idx="34">
                  <c:v>7C421</c:v>
                </c:pt>
                <c:pt idx="35">
                  <c:v>QC01</c:v>
                </c:pt>
              </c:strCache>
            </c:strRef>
          </c:cat>
          <c:val>
            <c:numRef>
              <c:f>'0(no event), 1(loss), 2(gain)'!$C$198:$C$233</c:f>
              <c:numCache>
                <c:formatCode>General</c:formatCode>
                <c:ptCount val="36"/>
                <c:pt idx="0">
                  <c:v>21</c:v>
                </c:pt>
                <c:pt idx="1">
                  <c:v>32</c:v>
                </c:pt>
                <c:pt idx="2">
                  <c:v>28</c:v>
                </c:pt>
                <c:pt idx="3">
                  <c:v>25</c:v>
                </c:pt>
                <c:pt idx="4">
                  <c:v>19</c:v>
                </c:pt>
                <c:pt idx="5">
                  <c:v>19</c:v>
                </c:pt>
                <c:pt idx="6">
                  <c:v>17</c:v>
                </c:pt>
                <c:pt idx="7">
                  <c:v>17</c:v>
                </c:pt>
                <c:pt idx="8">
                  <c:v>17</c:v>
                </c:pt>
                <c:pt idx="9">
                  <c:v>17</c:v>
                </c:pt>
                <c:pt idx="10">
                  <c:v>16</c:v>
                </c:pt>
                <c:pt idx="11">
                  <c:v>15</c:v>
                </c:pt>
                <c:pt idx="12">
                  <c:v>15</c:v>
                </c:pt>
                <c:pt idx="13">
                  <c:v>15</c:v>
                </c:pt>
                <c:pt idx="14">
                  <c:v>15</c:v>
                </c:pt>
                <c:pt idx="15">
                  <c:v>15</c:v>
                </c:pt>
                <c:pt idx="16">
                  <c:v>14</c:v>
                </c:pt>
                <c:pt idx="17">
                  <c:v>14</c:v>
                </c:pt>
                <c:pt idx="18">
                  <c:v>13</c:v>
                </c:pt>
                <c:pt idx="19">
                  <c:v>13</c:v>
                </c:pt>
                <c:pt idx="20">
                  <c:v>12</c:v>
                </c:pt>
                <c:pt idx="21">
                  <c:v>12</c:v>
                </c:pt>
                <c:pt idx="22">
                  <c:v>12</c:v>
                </c:pt>
                <c:pt idx="23">
                  <c:v>11</c:v>
                </c:pt>
                <c:pt idx="24">
                  <c:v>11</c:v>
                </c:pt>
                <c:pt idx="25">
                  <c:v>10</c:v>
                </c:pt>
                <c:pt idx="26">
                  <c:v>10</c:v>
                </c:pt>
                <c:pt idx="27">
                  <c:v>10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7</c:v>
                </c:pt>
                <c:pt idx="33">
                  <c:v>6</c:v>
                </c:pt>
                <c:pt idx="34">
                  <c:v>5</c:v>
                </c:pt>
                <c:pt idx="35">
                  <c:v>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0671488"/>
        <c:axId val="52189952"/>
      </c:barChart>
      <c:catAx>
        <c:axId val="1806714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Parent/progeny</a:t>
                </a:r>
              </a:p>
            </c:rich>
          </c:tx>
          <c:layout>
            <c:manualLayout>
              <c:xMode val="edge"/>
              <c:yMode val="edge"/>
              <c:x val="0.47234486018261129"/>
              <c:y val="0.92770085557487736"/>
            </c:manualLayout>
          </c:layout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52189952"/>
        <c:crosses val="autoZero"/>
        <c:auto val="1"/>
        <c:lblAlgn val="ctr"/>
        <c:lblOffset val="100"/>
        <c:noMultiLvlLbl val="0"/>
      </c:catAx>
      <c:valAx>
        <c:axId val="52189952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Frequency of  loss/gain </a:t>
                </a:r>
                <a:endParaRPr lang="en-US" b="0" dirty="0"/>
              </a:p>
            </c:rich>
          </c:tx>
          <c:layout>
            <c:manualLayout>
              <c:xMode val="edge"/>
              <c:yMode val="edge"/>
              <c:x val="3.8349369098864695E-2"/>
              <c:y val="0.24756561233440669"/>
            </c:manualLayout>
          </c:layout>
          <c:overlay val="0"/>
        </c:title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80671488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83500742081907464"/>
          <c:y val="8.6863687493608684E-3"/>
          <c:w val="0.13170305245507846"/>
          <c:h val="9.2891024985513243E-2"/>
        </c:manualLayout>
      </c:layout>
      <c:overlay val="1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F08404-BDC8-483E-90F5-327CC08E27C2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801688" y="685800"/>
            <a:ext cx="52546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24E383-8BCE-4326-98EF-92369EB1AA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1789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373723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747445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1121168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1494890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1868614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6pPr>
    <a:lvl7pPr marL="2242337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7pPr>
    <a:lvl8pPr marL="2616059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8pPr>
    <a:lvl9pPr marL="2989782" algn="l" defTabSz="747445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801688" y="685800"/>
            <a:ext cx="52546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24E383-8BCE-4326-98EF-92369EB1AA0D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3755" y="1334970"/>
            <a:ext cx="5595859" cy="92114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7505" y="2435172"/>
            <a:ext cx="4608354" cy="10982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37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74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211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948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686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423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160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897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72943" y="172095"/>
            <a:ext cx="1481257" cy="366668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9169" y="172095"/>
            <a:ext cx="4334047" cy="366668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042" y="2761459"/>
            <a:ext cx="5595859" cy="853504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042" y="1821409"/>
            <a:ext cx="5595859" cy="940048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7372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74744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2116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9489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86861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242337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61605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98978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9168" y="1002720"/>
            <a:ext cx="2907652" cy="2836062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46543" y="1002720"/>
            <a:ext cx="2907652" cy="2836062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69" y="961939"/>
            <a:ext cx="2908795" cy="400887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73723" indent="0">
              <a:buNone/>
              <a:defRPr sz="1600" b="1"/>
            </a:lvl2pPr>
            <a:lvl3pPr marL="747445" indent="0">
              <a:buNone/>
              <a:defRPr sz="1400" b="1"/>
            </a:lvl3pPr>
            <a:lvl4pPr marL="1121168" indent="0">
              <a:buNone/>
              <a:defRPr sz="1300" b="1"/>
            </a:lvl4pPr>
            <a:lvl5pPr marL="1494890" indent="0">
              <a:buNone/>
              <a:defRPr sz="1300" b="1"/>
            </a:lvl5pPr>
            <a:lvl6pPr marL="1868614" indent="0">
              <a:buNone/>
              <a:defRPr sz="1300" b="1"/>
            </a:lvl6pPr>
            <a:lvl7pPr marL="2242337" indent="0">
              <a:buNone/>
              <a:defRPr sz="1300" b="1"/>
            </a:lvl7pPr>
            <a:lvl8pPr marL="2616059" indent="0">
              <a:buNone/>
              <a:defRPr sz="1300" b="1"/>
            </a:lvl8pPr>
            <a:lvl9pPr marL="2989782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9169" y="1362824"/>
            <a:ext cx="2908795" cy="2475958"/>
          </a:xfrm>
        </p:spPr>
        <p:txBody>
          <a:bodyPr/>
          <a:lstStyle>
            <a:lvl1pPr>
              <a:defRPr sz="20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44257" y="961939"/>
            <a:ext cx="2909940" cy="400887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73723" indent="0">
              <a:buNone/>
              <a:defRPr sz="1600" b="1"/>
            </a:lvl2pPr>
            <a:lvl3pPr marL="747445" indent="0">
              <a:buNone/>
              <a:defRPr sz="1400" b="1"/>
            </a:lvl3pPr>
            <a:lvl4pPr marL="1121168" indent="0">
              <a:buNone/>
              <a:defRPr sz="1300" b="1"/>
            </a:lvl4pPr>
            <a:lvl5pPr marL="1494890" indent="0">
              <a:buNone/>
              <a:defRPr sz="1300" b="1"/>
            </a:lvl5pPr>
            <a:lvl6pPr marL="1868614" indent="0">
              <a:buNone/>
              <a:defRPr sz="1300" b="1"/>
            </a:lvl6pPr>
            <a:lvl7pPr marL="2242337" indent="0">
              <a:buNone/>
              <a:defRPr sz="1300" b="1"/>
            </a:lvl7pPr>
            <a:lvl8pPr marL="2616059" indent="0">
              <a:buNone/>
              <a:defRPr sz="1300" b="1"/>
            </a:lvl8pPr>
            <a:lvl9pPr marL="2989782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44257" y="1362824"/>
            <a:ext cx="2909940" cy="2475958"/>
          </a:xfrm>
        </p:spPr>
        <p:txBody>
          <a:bodyPr/>
          <a:lstStyle>
            <a:lvl1pPr>
              <a:defRPr sz="20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9170" y="171099"/>
            <a:ext cx="2165880" cy="728165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73915" y="171102"/>
            <a:ext cx="3680283" cy="3667681"/>
          </a:xfrm>
        </p:spPr>
        <p:txBody>
          <a:bodyPr/>
          <a:lstStyle>
            <a:lvl1pPr>
              <a:defRPr sz="2600"/>
            </a:lvl1pPr>
            <a:lvl2pPr>
              <a:defRPr sz="2300"/>
            </a:lvl2pPr>
            <a:lvl3pPr>
              <a:defRPr sz="20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9170" y="899267"/>
            <a:ext cx="2165880" cy="2939516"/>
          </a:xfrm>
        </p:spPr>
        <p:txBody>
          <a:bodyPr/>
          <a:lstStyle>
            <a:lvl1pPr marL="0" indent="0">
              <a:buNone/>
              <a:defRPr sz="1100"/>
            </a:lvl1pPr>
            <a:lvl2pPr marL="373723" indent="0">
              <a:buNone/>
              <a:defRPr sz="1000"/>
            </a:lvl2pPr>
            <a:lvl3pPr marL="747445" indent="0">
              <a:buNone/>
              <a:defRPr sz="900"/>
            </a:lvl3pPr>
            <a:lvl4pPr marL="1121168" indent="0">
              <a:buNone/>
              <a:defRPr sz="800"/>
            </a:lvl4pPr>
            <a:lvl5pPr marL="1494890" indent="0">
              <a:buNone/>
              <a:defRPr sz="800"/>
            </a:lvl5pPr>
            <a:lvl6pPr marL="1868614" indent="0">
              <a:buNone/>
              <a:defRPr sz="800"/>
            </a:lvl6pPr>
            <a:lvl7pPr marL="2242337" indent="0">
              <a:buNone/>
              <a:defRPr sz="800"/>
            </a:lvl7pPr>
            <a:lvl8pPr marL="2616059" indent="0">
              <a:buNone/>
              <a:defRPr sz="800"/>
            </a:lvl8pPr>
            <a:lvl9pPr marL="2989782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90385" y="3008156"/>
            <a:ext cx="3950018" cy="355129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90385" y="383979"/>
            <a:ext cx="3950018" cy="2578418"/>
          </a:xfrm>
        </p:spPr>
        <p:txBody>
          <a:bodyPr/>
          <a:lstStyle>
            <a:lvl1pPr marL="0" indent="0">
              <a:buNone/>
              <a:defRPr sz="2600"/>
            </a:lvl1pPr>
            <a:lvl2pPr marL="373723" indent="0">
              <a:buNone/>
              <a:defRPr sz="2300"/>
            </a:lvl2pPr>
            <a:lvl3pPr marL="747445" indent="0">
              <a:buNone/>
              <a:defRPr sz="2000"/>
            </a:lvl3pPr>
            <a:lvl4pPr marL="1121168" indent="0">
              <a:buNone/>
              <a:defRPr sz="1600"/>
            </a:lvl4pPr>
            <a:lvl5pPr marL="1494890" indent="0">
              <a:buNone/>
              <a:defRPr sz="1600"/>
            </a:lvl5pPr>
            <a:lvl6pPr marL="1868614" indent="0">
              <a:buNone/>
              <a:defRPr sz="1600"/>
            </a:lvl6pPr>
            <a:lvl7pPr marL="2242337" indent="0">
              <a:buNone/>
              <a:defRPr sz="1600"/>
            </a:lvl7pPr>
            <a:lvl8pPr marL="2616059" indent="0">
              <a:buNone/>
              <a:defRPr sz="1600"/>
            </a:lvl8pPr>
            <a:lvl9pPr marL="2989782" indent="0">
              <a:buNone/>
              <a:defRPr sz="1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90385" y="3363289"/>
            <a:ext cx="3950018" cy="504343"/>
          </a:xfrm>
        </p:spPr>
        <p:txBody>
          <a:bodyPr/>
          <a:lstStyle>
            <a:lvl1pPr marL="0" indent="0">
              <a:buNone/>
              <a:defRPr sz="1100"/>
            </a:lvl1pPr>
            <a:lvl2pPr marL="373723" indent="0">
              <a:buNone/>
              <a:defRPr sz="1000"/>
            </a:lvl2pPr>
            <a:lvl3pPr marL="747445" indent="0">
              <a:buNone/>
              <a:defRPr sz="900"/>
            </a:lvl3pPr>
            <a:lvl4pPr marL="1121168" indent="0">
              <a:buNone/>
              <a:defRPr sz="800"/>
            </a:lvl4pPr>
            <a:lvl5pPr marL="1494890" indent="0">
              <a:buNone/>
              <a:defRPr sz="800"/>
            </a:lvl5pPr>
            <a:lvl6pPr marL="1868614" indent="0">
              <a:buNone/>
              <a:defRPr sz="800"/>
            </a:lvl6pPr>
            <a:lvl7pPr marL="2242337" indent="0">
              <a:buNone/>
              <a:defRPr sz="800"/>
            </a:lvl7pPr>
            <a:lvl8pPr marL="2616059" indent="0">
              <a:buNone/>
              <a:defRPr sz="800"/>
            </a:lvl8pPr>
            <a:lvl9pPr marL="2989782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9171" y="172094"/>
            <a:ext cx="5925027" cy="716227"/>
          </a:xfrm>
          <a:prstGeom prst="rect">
            <a:avLst/>
          </a:prstGeom>
        </p:spPr>
        <p:txBody>
          <a:bodyPr vert="horz" lIns="74744" tIns="37373" rIns="74744" bIns="3737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71" y="1002720"/>
            <a:ext cx="5925027" cy="2836062"/>
          </a:xfrm>
          <a:prstGeom prst="rect">
            <a:avLst/>
          </a:prstGeom>
        </p:spPr>
        <p:txBody>
          <a:bodyPr vert="horz" lIns="74744" tIns="37373" rIns="74744" bIns="3737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9168" y="3983020"/>
            <a:ext cx="1536118" cy="228794"/>
          </a:xfrm>
          <a:prstGeom prst="rect">
            <a:avLst/>
          </a:prstGeom>
        </p:spPr>
        <p:txBody>
          <a:bodyPr vert="horz" lIns="74744" tIns="37373" rIns="74744" bIns="37373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FDA1A6-AFD0-45E4-A714-5C5D78950AB6}" type="datetimeFigureOut">
              <a:rPr lang="en-US" smtClean="0"/>
              <a:t>10/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49316" y="3983020"/>
            <a:ext cx="2084732" cy="228794"/>
          </a:xfrm>
          <a:prstGeom prst="rect">
            <a:avLst/>
          </a:prstGeom>
        </p:spPr>
        <p:txBody>
          <a:bodyPr vert="horz" lIns="74744" tIns="37373" rIns="74744" bIns="37373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8077" y="3983020"/>
            <a:ext cx="1536118" cy="228794"/>
          </a:xfrm>
          <a:prstGeom prst="rect">
            <a:avLst/>
          </a:prstGeom>
        </p:spPr>
        <p:txBody>
          <a:bodyPr vert="horz" lIns="74744" tIns="37373" rIns="74744" bIns="37373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6988D5-0EC4-41C6-9E13-E94AA04DE15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47445" rtl="0" eaLnBrk="1" latinLnBrk="0" hangingPunct="1"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0292" indent="-280292" algn="l" defTabSz="747445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07299" indent="-233576" algn="l" defTabSz="747445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934307" indent="-186861" algn="l" defTabSz="74744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308029" indent="-186861" algn="l" defTabSz="747445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81753" indent="-186861" algn="l" defTabSz="747445" rtl="0" eaLnBrk="1" latinLnBrk="0" hangingPunct="1">
        <a:spcBef>
          <a:spcPct val="20000"/>
        </a:spcBef>
        <a:buFont typeface="Arial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55475" indent="-186861" algn="l" defTabSz="747445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29198" indent="-186861" algn="l" defTabSz="747445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02920" indent="-186861" algn="l" defTabSz="747445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76643" indent="-186861" algn="l" defTabSz="747445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73723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47445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1168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94890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68614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242337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616059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989782" algn="l" defTabSz="747445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-137319" y="78285"/>
            <a:ext cx="6624255" cy="4181729"/>
            <a:chOff x="43245" y="-97920"/>
            <a:chExt cx="6624255" cy="4181729"/>
          </a:xfrm>
        </p:grpSpPr>
        <p:grpSp>
          <p:nvGrpSpPr>
            <p:cNvPr id="27" name="Group 23"/>
            <p:cNvGrpSpPr>
              <a:grpSpLocks noChangeAspect="1"/>
            </p:cNvGrpSpPr>
            <p:nvPr/>
          </p:nvGrpSpPr>
          <p:grpSpPr>
            <a:xfrm>
              <a:off x="43245" y="-35249"/>
              <a:ext cx="6624255" cy="3412049"/>
              <a:chOff x="923286" y="1595437"/>
              <a:chExt cx="7501576" cy="3863941"/>
            </a:xfrm>
          </p:grpSpPr>
          <p:graphicFrame>
            <p:nvGraphicFramePr>
              <p:cNvPr id="30" name="Chart 29"/>
              <p:cNvGraphicFramePr/>
              <p:nvPr>
                <p:extLst>
                  <p:ext uri="{D42A27DB-BD31-4B8C-83A1-F6EECF244321}">
                    <p14:modId xmlns:p14="http://schemas.microsoft.com/office/powerpoint/2010/main" val="4256141717"/>
                  </p:ext>
                </p:extLst>
              </p:nvPr>
            </p:nvGraphicFramePr>
            <p:xfrm>
              <a:off x="923286" y="1595437"/>
              <a:ext cx="7501576" cy="386394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cxnSp>
            <p:nvCxnSpPr>
              <p:cNvPr id="31" name="Straight Connector 30"/>
              <p:cNvCxnSpPr/>
              <p:nvPr/>
            </p:nvCxnSpPr>
            <p:spPr>
              <a:xfrm>
                <a:off x="2106304" y="3186752"/>
                <a:ext cx="6126480" cy="0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Rectangle 27"/>
            <p:cNvSpPr/>
            <p:nvPr/>
          </p:nvSpPr>
          <p:spPr>
            <a:xfrm>
              <a:off x="266700" y="-97920"/>
              <a:ext cx="6400800" cy="347472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1"/>
            <p:cNvSpPr>
              <a:spLocks noChangeArrowheads="1"/>
            </p:cNvSpPr>
            <p:nvPr/>
          </p:nvSpPr>
          <p:spPr bwMode="auto">
            <a:xfrm>
              <a:off x="290450" y="3152845"/>
              <a:ext cx="6294120" cy="9309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0" tIns="152352" rIns="0" bIns="38088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2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Additional file 3  – Loss and gain frequency of CNVs across the progeny</a:t>
              </a:r>
              <a:r>
                <a:rPr kumimoji="0" lang="en-GB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. </a:t>
              </a:r>
            </a:p>
            <a:p>
              <a:pPr marL="0" marR="0" lvl="0" indent="0" algn="l" defTabSz="914400" rtl="0" eaLnBrk="1" fontAlgn="base" latinLnBrk="0" hangingPunct="1"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In general the progeny population shows an accumulation of gains than losses (average gain = 14, average loss = 11). 69% of the progeny have more gains than losses.</a:t>
              </a:r>
              <a:endParaRPr kumimoji="0" lang="en-GB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54</Words>
  <Application>Microsoft Office PowerPoint</Application>
  <PresentationFormat>Custom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peka</dc:creator>
  <cp:lastModifiedBy>Upeka Samarakoon</cp:lastModifiedBy>
  <cp:revision>4</cp:revision>
  <dcterms:created xsi:type="dcterms:W3CDTF">2011-07-04T05:10:22Z</dcterms:created>
  <dcterms:modified xsi:type="dcterms:W3CDTF">2011-10-05T14:34:58Z</dcterms:modified>
</cp:coreProperties>
</file>